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2" r:id="rId2"/>
    <p:sldId id="265" r:id="rId3"/>
    <p:sldId id="269" r:id="rId4"/>
    <p:sldId id="27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AEE4F6-2576-4372-A875-9A4917A57599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395722-C98B-4394-9530-35D523993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8738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910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444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774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94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943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474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155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647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914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985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129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60C79B-C4A2-4AD6-9E90-F87AD8B1636E}" type="datetimeFigureOut">
              <a:rPr lang="en-US" smtClean="0"/>
              <a:t>7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C0FE10-3FE4-47D1-BB8F-BD3CCA11A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897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jeespark@korea.kr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13238" y="768753"/>
            <a:ext cx="11623431" cy="38472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meliorative Effects of Newly Developed Citrus Hybrid ‘Mubong’ Peel Extract on Experimental Colitis and Gut Microbiota </a:t>
            </a:r>
            <a:r>
              <a:rPr lang="en-US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ysbiosis</a:t>
            </a:r>
          </a:p>
          <a:p>
            <a:pPr algn="just">
              <a:spcAft>
                <a:spcPts val="800"/>
              </a:spcAft>
            </a:pP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wraris Derbie Assefa</a:t>
            </a:r>
            <a:r>
              <a:rPr lang="en-US" b="1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sz="1400" baseline="30000" dirty="0" smtClean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†</a:t>
            </a: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Sang Suk Kim</a:t>
            </a:r>
            <a:r>
              <a:rPr lang="en-US" b="1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sz="1400" baseline="30000" dirty="0" smtClean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†</a:t>
            </a: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b="1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eung</a:t>
            </a: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Gab Han</a:t>
            </a:r>
            <a:r>
              <a:rPr lang="en-US" b="1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b="1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YoSup</a:t>
            </a: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Park</a:t>
            </a:r>
            <a:r>
              <a:rPr lang="en-US" b="1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Jee-Soo Park</a:t>
            </a:r>
            <a:r>
              <a:rPr lang="en-US" b="1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*</a:t>
            </a:r>
            <a:endParaRPr lang="en-US" dirty="0" smtClean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itrus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search Center, National Institute of Horticultural &amp; Herbal Science, Rural Development Administration, Seogwipo 63607, Korea, Republic of</a:t>
            </a:r>
            <a:endParaRPr lang="en-US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partment of Herbal Crop Research, National Institute of Horticultural &amp; Herbal Science, Rural Development Administration, Eumseong 27709, Korea, Republic of</a:t>
            </a:r>
            <a:endParaRPr lang="en-US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2000" baseline="3000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r>
              <a:rPr lang="en-US" sz="200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partment </a:t>
            </a:r>
            <a:r>
              <a:rPr lang="en-US" sz="2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f Horticultural Science, School of Horticulture and Forest, Mokpo National University, </a:t>
            </a:r>
            <a:r>
              <a:rPr lang="en-US" sz="20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uan</a:t>
            </a:r>
            <a:r>
              <a:rPr lang="en-US" sz="2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58554, Korea, Republic of.</a:t>
            </a:r>
            <a:endParaRPr lang="en-US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*Correspondence: Jee-Soo Park,  Email: </a:t>
            </a:r>
            <a:r>
              <a:rPr lang="en-US" u="sng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hlinkClick r:id="rId2"/>
              </a:rPr>
              <a:t>jeespark@korea.kr</a:t>
            </a:r>
            <a:endParaRPr lang="en-US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† These authors should be considered joint first author</a:t>
            </a:r>
            <a:endParaRPr lang="en-US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8016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738" y="342900"/>
            <a:ext cx="4260169" cy="2827094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3907" y="711273"/>
            <a:ext cx="3624182" cy="245871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7273" y="807938"/>
            <a:ext cx="3332285" cy="226539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339" y="3588721"/>
            <a:ext cx="4160515" cy="2760963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1854" y="3492056"/>
            <a:ext cx="4095419" cy="277263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8089" y="3588720"/>
            <a:ext cx="3944421" cy="2675975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695172" y="6421812"/>
            <a:ext cx="918738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 smtClean="0"/>
              <a:t>Supporting Figure S1. </a:t>
            </a:r>
            <a:r>
              <a:rPr lang="en-US" sz="1100" dirty="0"/>
              <a:t>Correlation </a:t>
            </a:r>
            <a:r>
              <a:rPr lang="en-US" sz="1100" dirty="0" smtClean="0"/>
              <a:t>of Shannon's </a:t>
            </a:r>
            <a:r>
              <a:rPr lang="en-US" sz="1100" dirty="0"/>
              <a:t>and Pielou's evenness indices </a:t>
            </a:r>
            <a:r>
              <a:rPr lang="en-US" sz="1100" dirty="0" smtClean="0"/>
              <a:t>with </a:t>
            </a:r>
            <a:r>
              <a:rPr lang="en-US" sz="1100" dirty="0"/>
              <a:t>the weight of the thymus and the length of the colon</a:t>
            </a:r>
          </a:p>
        </p:txBody>
      </p:sp>
    </p:spTree>
    <p:extLst>
      <p:ext uri="{BB962C8B-B14F-4D97-AF65-F5344CB8AC3E}">
        <p14:creationId xmlns:p14="http://schemas.microsoft.com/office/powerpoint/2010/main" val="7958780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283" y="152355"/>
            <a:ext cx="3706542" cy="185573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5162" y="112254"/>
            <a:ext cx="3844632" cy="192487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613" y="2237195"/>
            <a:ext cx="3824681" cy="191488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6848" y="84333"/>
            <a:ext cx="3827930" cy="191651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0611" y="4351739"/>
            <a:ext cx="3942217" cy="196848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5162" y="2225369"/>
            <a:ext cx="3813113" cy="190909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34161" y="2230554"/>
            <a:ext cx="3760617" cy="187780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719" y="4351739"/>
            <a:ext cx="3910467" cy="1957837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8310110" y="5207979"/>
            <a:ext cx="3684668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 smtClean="0"/>
              <a:t>Supporting </a:t>
            </a:r>
            <a:r>
              <a:rPr lang="en-US" sz="1100" dirty="0"/>
              <a:t>Figure </a:t>
            </a:r>
            <a:r>
              <a:rPr lang="en-US" sz="1100" dirty="0" smtClean="0"/>
              <a:t>S2. Major </a:t>
            </a:r>
            <a:r>
              <a:rPr lang="en-US" sz="1100" dirty="0"/>
              <a:t>bacterial genera that exhibited distinctive distribution patterns across the groups</a:t>
            </a:r>
          </a:p>
        </p:txBody>
      </p:sp>
    </p:spTree>
    <p:extLst>
      <p:ext uri="{BB962C8B-B14F-4D97-AF65-F5344CB8AC3E}">
        <p14:creationId xmlns:p14="http://schemas.microsoft.com/office/powerpoint/2010/main" val="2797953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032" y="5075311"/>
            <a:ext cx="119575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Supporting </a:t>
            </a:r>
            <a:r>
              <a:rPr lang="en-US" sz="1200" dirty="0"/>
              <a:t>Figure </a:t>
            </a:r>
            <a:r>
              <a:rPr lang="en-US" sz="1200" dirty="0" smtClean="0"/>
              <a:t>S3. </a:t>
            </a:r>
            <a:r>
              <a:rPr lang="en-US" sz="1200" dirty="0"/>
              <a:t>Metabolic pathway prediction based on </a:t>
            </a:r>
            <a:r>
              <a:rPr lang="en-US" sz="1200" dirty="0" smtClean="0"/>
              <a:t>PCoA: Bray Curtis dissimilarity (A) and Jaccard similarity index (B). Each </a:t>
            </a:r>
            <a:r>
              <a:rPr lang="en-US" sz="1200" dirty="0"/>
              <a:t>point represents an individual sample, and samples with similar metabolic pathways are positioned close to one another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1" y="1150348"/>
            <a:ext cx="5969214" cy="324370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6800" y="1303541"/>
            <a:ext cx="6232131" cy="315415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10532" y="77450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366210" y="78101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9320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65</TotalTime>
  <Words>208</Words>
  <Application>Microsoft Office PowerPoint</Application>
  <PresentationFormat>Widescreen</PresentationFormat>
  <Paragraphs>1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Malgun Gothic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</dc:creator>
  <cp:lastModifiedBy>po</cp:lastModifiedBy>
  <cp:revision>109</cp:revision>
  <dcterms:created xsi:type="dcterms:W3CDTF">2025-10-20T07:52:27Z</dcterms:created>
  <dcterms:modified xsi:type="dcterms:W3CDTF">2026-07-01T04:29:19Z</dcterms:modified>
</cp:coreProperties>
</file>